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1" d="100"/>
          <a:sy n="51" d="100"/>
        </p:scale>
        <p:origin x="23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5886FCBB-F41C-42F7-933B-7BDE3AE3053C}"/>
    <pc:docChg chg="undo custSel modSld">
      <pc:chgData name="OKAGAWA Tomohiro" userId="d74b3e309c52a267" providerId="LiveId" clId="{5886FCBB-F41C-42F7-933B-7BDE3AE3053C}" dt="2021-12-28T02:15:46.007" v="772" actId="1038"/>
      <pc:docMkLst>
        <pc:docMk/>
      </pc:docMkLst>
      <pc:sldChg chg="addSp modSp mod">
        <pc:chgData name="OKAGAWA Tomohiro" userId="d74b3e309c52a267" providerId="LiveId" clId="{5886FCBB-F41C-42F7-933B-7BDE3AE3053C}" dt="2021-12-28T02:15:46.007" v="772" actId="1038"/>
        <pc:sldMkLst>
          <pc:docMk/>
          <pc:sldMk cId="2879998273" sldId="256"/>
        </pc:sldMkLst>
        <pc:spChg chg="add mod">
          <ac:chgData name="OKAGAWA Tomohiro" userId="d74b3e309c52a267" providerId="LiveId" clId="{5886FCBB-F41C-42F7-933B-7BDE3AE3053C}" dt="2021-12-28T01:56:57.007" v="38" actId="1076"/>
          <ac:spMkLst>
            <pc:docMk/>
            <pc:sldMk cId="2879998273" sldId="256"/>
            <ac:spMk id="3" creationId="{3C71BA40-4C5F-4E3E-9FDF-10D59AB43C66}"/>
          </ac:spMkLst>
        </pc:spChg>
        <pc:graphicFrameChg chg="mod modGraphic">
          <ac:chgData name="OKAGAWA Tomohiro" userId="d74b3e309c52a267" providerId="LiveId" clId="{5886FCBB-F41C-42F7-933B-7BDE3AE3053C}" dt="2021-12-28T02:15:46.007" v="772" actId="1038"/>
          <ac:graphicFrameMkLst>
            <pc:docMk/>
            <pc:sldMk cId="2879998273" sldId="256"/>
            <ac:graphicFrameMk id="5" creationId="{28AA4524-C1F8-4974-A5E6-93C4C8CE70A8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9.635" v="763" actId="12788"/>
        <pc:sldMkLst>
          <pc:docMk/>
          <pc:sldMk cId="2176500321" sldId="257"/>
        </pc:sldMkLst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8" creationId="{CECC3651-6356-42BA-90D4-D53D8AF637D3}"/>
          </ac:spMkLst>
        </pc:spChg>
        <pc:spChg chg="mod">
          <ac:chgData name="OKAGAWA Tomohiro" userId="d74b3e309c52a267" providerId="LiveId" clId="{5886FCBB-F41C-42F7-933B-7BDE3AE3053C}" dt="2021-12-28T01:59:28.193" v="107" actId="14100"/>
          <ac:spMkLst>
            <pc:docMk/>
            <pc:sldMk cId="2176500321" sldId="257"/>
            <ac:spMk id="9" creationId="{847F998F-4C07-4B5A-A9F3-01507E6D6A75}"/>
          </ac:spMkLst>
        </pc:spChg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10" creationId="{FDE252EE-D3A8-4DB5-8025-9A869134AB24}"/>
          </ac:spMkLst>
        </pc:spChg>
        <pc:spChg chg="mod">
          <ac:chgData name="OKAGAWA Tomohiro" userId="d74b3e309c52a267" providerId="LiveId" clId="{5886FCBB-F41C-42F7-933B-7BDE3AE3053C}" dt="2021-12-28T01:59:24.992" v="106" actId="552"/>
          <ac:spMkLst>
            <pc:docMk/>
            <pc:sldMk cId="2176500321" sldId="257"/>
            <ac:spMk id="11" creationId="{182492F5-D548-4006-A7D9-7D539CD3BF35}"/>
          </ac:spMkLst>
        </pc:spChg>
        <pc:spChg chg="add mod">
          <ac:chgData name="OKAGAWA Tomohiro" userId="d74b3e309c52a267" providerId="LiveId" clId="{5886FCBB-F41C-42F7-933B-7BDE3AE3053C}" dt="2021-12-28T02:15:39.635" v="763" actId="12788"/>
          <ac:spMkLst>
            <pc:docMk/>
            <pc:sldMk cId="2176500321" sldId="257"/>
            <ac:spMk id="12" creationId="{388C4F0B-C68F-487B-8066-CF13BA86AD47}"/>
          </ac:spMkLst>
        </pc:spChg>
      </pc:sldChg>
      <pc:sldChg chg="addSp modSp mod">
        <pc:chgData name="OKAGAWA Tomohiro" userId="d74b3e309c52a267" providerId="LiveId" clId="{5886FCBB-F41C-42F7-933B-7BDE3AE3053C}" dt="2021-12-28T02:15:34.905" v="762" actId="12788"/>
        <pc:sldMkLst>
          <pc:docMk/>
          <pc:sldMk cId="3092454316" sldId="258"/>
        </pc:sldMkLst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5" creationId="{AD53BC56-9CD9-4537-BC22-509DD5F5CF28}"/>
          </ac:spMkLst>
        </pc:spChg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7" creationId="{06A4BC64-B92B-46C5-B952-67D03CDA8590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9" creationId="{FC20F88B-779B-4B8E-9592-36D12D5934CB}"/>
          </ac:spMkLst>
        </pc:spChg>
        <pc:spChg chg="add mod">
          <ac:chgData name="OKAGAWA Tomohiro" userId="d74b3e309c52a267" providerId="LiveId" clId="{5886FCBB-F41C-42F7-933B-7BDE3AE3053C}" dt="2021-12-28T02:15:34.905" v="762" actId="12788"/>
          <ac:spMkLst>
            <pc:docMk/>
            <pc:sldMk cId="3092454316" sldId="258"/>
            <ac:spMk id="12" creationId="{03367787-1E0C-454E-9F9C-AD79F92BB878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3" creationId="{04C3066E-2124-4B3A-A634-79A06F62DFAE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5" creationId="{B5C586AD-A457-4A2F-B5AB-05587D506C9B}"/>
          </ac:spMkLst>
        </pc:sp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4" creationId="{51D5F3E7-2D88-4977-9F1F-E68466E5775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6" creationId="{8D9A3B75-ED18-42AC-BA85-8E4D135AE78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0" creationId="{2F66BED3-B3FF-4B8B-ADB5-60003887B286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1" creationId="{DF1EE0C2-391D-4AF4-848F-B89D1098CCD9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4" creationId="{633FAB34-FE47-4EF9-B7B0-908C0DEE818E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0.670" v="761" actId="12788"/>
        <pc:sldMkLst>
          <pc:docMk/>
          <pc:sldMk cId="4162683584" sldId="259"/>
        </pc:sldMkLst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0" creationId="{FDE252EE-D3A8-4DB5-8025-9A869134AB24}"/>
          </ac:spMkLst>
        </pc:spChg>
        <pc:spChg chg="add mod">
          <ac:chgData name="OKAGAWA Tomohiro" userId="d74b3e309c52a267" providerId="LiveId" clId="{5886FCBB-F41C-42F7-933B-7BDE3AE3053C}" dt="2021-12-28T02:15:30.670" v="761" actId="12788"/>
          <ac:spMkLst>
            <pc:docMk/>
            <pc:sldMk cId="4162683584" sldId="259"/>
            <ac:spMk id="11" creationId="{110936BD-A3DB-4F7C-AF31-3592F0EA6EB6}"/>
          </ac:spMkLst>
        </pc:spChg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5" creationId="{917B32FB-9B87-4C4D-AA9B-FFC3E39069A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6" creationId="{AD5C1B79-42DB-4284-B402-5406663A737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7" creationId="{D41489B0-161B-4390-B14D-AF376C68EF1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983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15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270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917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207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979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272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51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75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611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411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081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D5C1B79-42DB-4284-B402-5406663A737A}"/>
              </a:ext>
            </a:extLst>
          </p:cNvPr>
          <p:cNvSpPr txBox="1"/>
          <p:nvPr/>
        </p:nvSpPr>
        <p:spPr>
          <a:xfrm>
            <a:off x="3598050" y="337225"/>
            <a:ext cx="2305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PGE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17B32FB-9B87-4C4D-AA9B-FFC3E39069AA}"/>
              </a:ext>
            </a:extLst>
          </p:cNvPr>
          <p:cNvSpPr txBox="1"/>
          <p:nvPr/>
        </p:nvSpPr>
        <p:spPr>
          <a:xfrm>
            <a:off x="476410" y="356330"/>
            <a:ext cx="2305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stradiol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DE252EE-D3A8-4DB5-8025-9A869134AB24}"/>
              </a:ext>
            </a:extLst>
          </p:cNvPr>
          <p:cNvSpPr txBox="1"/>
          <p:nvPr/>
        </p:nvSpPr>
        <p:spPr>
          <a:xfrm>
            <a:off x="476410" y="2980485"/>
            <a:ext cx="26301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IFN-γ (ng/mL):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response to Con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D7D5D0C2-8DCC-4A25-8121-7F82D85F9A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5283004"/>
              </p:ext>
            </p:extLst>
          </p:nvPr>
        </p:nvGraphicFramePr>
        <p:xfrm>
          <a:off x="771605" y="832324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406740848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346706670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36249611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7364983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3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35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44943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2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142849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6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0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707975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2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03954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0.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464633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2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2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117199"/>
                  </a:ext>
                </a:extLst>
              </a:tr>
            </a:tbl>
          </a:graphicData>
        </a:graphic>
      </p:graphicFrame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6E4DDEC4-F8F0-428A-9CE9-0DB85C4D5D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1254047"/>
              </p:ext>
            </p:extLst>
          </p:nvPr>
        </p:nvGraphicFramePr>
        <p:xfrm>
          <a:off x="3837535" y="832324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1331560679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3556868520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669439383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683773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2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4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459715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9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9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003128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6.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2.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902388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9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203681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0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4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123426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8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60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0718227"/>
                  </a:ext>
                </a:extLst>
              </a:tr>
            </a:tbl>
          </a:graphicData>
        </a:graphic>
      </p:graphicFrame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F45DF902-B2F9-4242-9F42-6E22ED1E95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1134894"/>
              </p:ext>
            </p:extLst>
          </p:nvPr>
        </p:nvGraphicFramePr>
        <p:xfrm>
          <a:off x="771605" y="3590892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208218637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342279093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194808394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5594069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4521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89659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383189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88939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511467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5040835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78AF31CB-2166-4320-9A15-D3B9FF5D02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4649140"/>
              </p:ext>
            </p:extLst>
          </p:nvPr>
        </p:nvGraphicFramePr>
        <p:xfrm>
          <a:off x="3837535" y="3590892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238798085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830573301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540956938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9446241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82.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1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99408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286356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4.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771922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9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138184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4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388407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1.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8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1390455"/>
                  </a:ext>
                </a:extLst>
              </a:tr>
            </a:tbl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41489B0-161B-4390-B14D-AF376C68EF15}"/>
              </a:ext>
            </a:extLst>
          </p:cNvPr>
          <p:cNvSpPr txBox="1"/>
          <p:nvPr/>
        </p:nvSpPr>
        <p:spPr>
          <a:xfrm>
            <a:off x="3598050" y="2980485"/>
            <a:ext cx="26301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IFN-γ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: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response to BLV antigen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10936BD-A3DB-4F7C-AF31-3592F0EA6EB6}"/>
              </a:ext>
            </a:extLst>
          </p:cNvPr>
          <p:cNvSpPr txBox="1"/>
          <p:nvPr/>
        </p:nvSpPr>
        <p:spPr>
          <a:xfrm>
            <a:off x="273050" y="5439988"/>
            <a:ext cx="63119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cs typeface="Times New Roman" panose="02020603050405020304" pitchFamily="18" charset="0"/>
              </a:rPr>
              <a:t>Supplementary Table 4.</a:t>
            </a:r>
          </a:p>
          <a:p>
            <a:pPr algn="just"/>
            <a:r>
              <a:rPr lang="en-US" altLang="ja-JP" sz="1200" dirty="0">
                <a:cs typeface="Times New Roman" panose="02020603050405020304" pitchFamily="18" charset="0"/>
              </a:rPr>
              <a:t>The original data of functional analysis of estradiol using BLV-infected cattle </a:t>
            </a:r>
            <a:r>
              <a:rPr lang="pt-BR" altLang="ja-JP" sz="1200" dirty="0">
                <a:cs typeface="Times New Roman" panose="02020603050405020304" pitchFamily="18" charset="0"/>
              </a:rPr>
              <a:t>(animals #6–#10)</a:t>
            </a:r>
            <a:r>
              <a:rPr lang="en-US" altLang="ja-JP" sz="1200" dirty="0">
                <a:cs typeface="Times New Roman" panose="02020603050405020304" pitchFamily="18" charset="0"/>
              </a:rPr>
              <a:t>, related to Figure 4.</a:t>
            </a:r>
          </a:p>
          <a:p>
            <a:pPr algn="just"/>
            <a:r>
              <a:rPr lang="en-US" altLang="ja-JP" sz="1200" dirty="0">
                <a:cs typeface="Times New Roman" panose="02020603050405020304" pitchFamily="18" charset="0"/>
              </a:rPr>
              <a:t>(a) The concentrations of estradiol in the sera. (b) The concentrations of PGE</a:t>
            </a:r>
            <a:r>
              <a:rPr lang="en-US" altLang="ja-JP" sz="1200" baseline="-25000" dirty="0"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cs typeface="Times New Roman" panose="02020603050405020304" pitchFamily="18" charset="0"/>
              </a:rPr>
              <a:t> in the sera. (c and d) IFN-γ production in response to Con A (c) or gp51 peptide mix (d) in the whole-blood cultures (c) or PBMC cultures (d).</a:t>
            </a:r>
          </a:p>
        </p:txBody>
      </p:sp>
    </p:spTree>
    <p:extLst>
      <p:ext uri="{BB962C8B-B14F-4D97-AF65-F5344CB8AC3E}">
        <p14:creationId xmlns:p14="http://schemas.microsoft.com/office/powerpoint/2010/main" val="4162683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per format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227</Words>
  <Application>Microsoft Office PowerPoint</Application>
  <PresentationFormat>On-screen Show (4:3)</PresentationFormat>
  <Paragraphs>9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治木 大和</dc:creator>
  <cp:lastModifiedBy>Saranya Siva</cp:lastModifiedBy>
  <cp:revision>7</cp:revision>
  <dcterms:created xsi:type="dcterms:W3CDTF">2021-12-25T03:57:05Z</dcterms:created>
  <dcterms:modified xsi:type="dcterms:W3CDTF">2022-02-15T03:42:59Z</dcterms:modified>
</cp:coreProperties>
</file>